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2" r:id="rId2"/>
    <p:sldId id="258" r:id="rId3"/>
    <p:sldId id="263" r:id="rId4"/>
    <p:sldId id="273" r:id="rId5"/>
    <p:sldId id="267" r:id="rId6"/>
    <p:sldId id="274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102" y="15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F2538B-436D-4FA9-94FA-1B4761189236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C79DF04-73E3-4FFB-AE5F-3BADBF716E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941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Islet viability on day 3 and 7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in control media or media supplemented with Nec-1 either immediately after islet isolation (D0 Nec-1) or on day 3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(D3 Nec-1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0 IEQs were stained with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cei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M 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A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for live cells and propidium iodide (PI) for dead and dying cells for 30 minutes on day 3 and 7 of tissue culture. The islet viability was calculated by the equation: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A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positive cells/(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lA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positive cells + PI-positive cells) x 100. n=5 for each group. Data expressed as mean ± SE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241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2. Flow cytometric analysis of the viability of PPIs on day 3 and 7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in control media or media supplemented with Nec-1 either immediately after islet isolation (D0 Nec-1) or on day 3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(D3 Nec-1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slets were dissociated on day 3 and 7 of tissue culture using Accutase, stained with 7-AAD viability dye, and analyzed by flow cytometry. n=5 for each group. Data expressed as mean ± SE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18396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3. Oxygen consumption rate of PPIs on day 3 and 7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in control media or media supplemented with Nec-1 either immediately after islet isolation (D0 Nec-1) or on day 3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(D3 Nec-1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0 IEQs per isolation was evaluated for the oxygen consumption rate on day 3 and 7 of tissue culture using a fiber optic sensor monitoring system and expressed as oxygen consumption rate normalized to the total DNA. n=5 for each group. Data expressed as mean ± SEM.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9748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. Long-term metabolic follow-up of diabetic athymic nude mice after islet transplantation with PPIs cultured for 7 days in control media (n=10, dashed red line) or media supplemented with Nec-1 on day 3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(n=11, solid blue line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ymic nude mice were rendered diabetic by an intraperitoneal streptozotocin injection, transplanted with 5000 IEQs of PPIs under the kidney capsule, and followed for 22 weeks. A) Average weekly non-fasting blood glucose measurements from 0 to 22 weeks after islet transplantation. B) Weekly non-fasting blood glucose measurements from 0 to 22 weeks of mice transplanted with PPIs cultured for 7 days in control media. C) Weekly non-fasting blood glucose measurements from 0 to 22 weeks of mice transplanted with PPIs cultured for 7 days in media supplemented with Nec-1 on day 3 of tissue culture. D) Average weekly body weight measurements from 0 to 22 weeks after islet transplantation. E) Porcine insulin measurements in serum of mice at 22 weeks after islet transplantation. F) Average blood glucose measurements during an OGTT (3 mg/kg) at 22 weeks after islet transplantation. G) Blood glucose measurements during an OGTT (3 mg/kg) of mice transplanted with PPIs cultured for 7 days in control media at 22 weeks after islet transplantation. H) Blood glucose measurements during an OGTT (3 mg/kg) of mice transplanted with PPIs cultured for 7 days in media supplemented with Nec-1 on day 3 of tissue culture at 22 weeks after islet transplantation. I) Glucose clearance after an OGTT (3 mg/kg) at 22 weeks post-transplantation expressed as AUC. Downward arrows indicate time of implantation of an insulin pellet. Upward arrows indicate time of nephrectomy of graft-bearing kidneys. Dotted black lines indicate the lower limit of the assay range (2.3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L). *p&lt;.05. **p&lt;.01. Data expressed as mean ± SE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6946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4. Long-term metabolic follow-up of diabetic athymic nude mice after islet transplantation with PPIs cultured for 7 days in control media (n=10, dashed red line) or media supplemented with Nec-1 on day 3 of tissu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 (n=11, solid blue line)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hymic nude mice were rendered diabetic by an intraperitoneal streptozotocin injection, transplanted with 5000 IEQs of PPIs under the kidney capsule, and followed for 22 weeks. A) Average weekly non-fasting blood glucose measurements from 0 to 22 weeks after islet transplantation. B) Weekly non-fasting blood glucose measurements from 0 to 22 weeks of mice transplanted with PPIs cultured for 7 days in control media. C) Weekly non-fasting blood glucose measurements from 0 to 22 weeks of mice transplanted with PPIs cultured for 7 days in media supplemented with Nec-1 on day 3 of tissue culture. D) Average weekly body weight measurements from 0 to 22 weeks after islet transplantation. E) Porcine insulin measurements in serum of mice at 22 weeks after islet transplantation. F) Average blood glucose measurements during an OGTT (3 mg/kg) at 22 weeks after islet transplantation. G) Blood glucose measurements during an OGTT (3 mg/kg) of mice transplanted with PPIs cultured for 7 days in control media at 22 weeks after islet transplantation. H) Blood glucose measurements during an OGTT (3 mg/kg) of mice transplanted with PPIs cultured for 7 days in media supplemented with Nec-1 on day 3 of tissue culture at 22 weeks after islet transplantation. I) Glucose clearance after an OGTT (3 mg/kg) at 22 weeks post-transplantation expressed as AUC. Downward arrows indicate time of implantation of an insulin pellet. Upward arrows indicate time of nephrectomy of graft-bearing kidneys. Dotted black lines indicate the lower limit of the assay range (2.3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/L). *p&lt;.05. **p&lt;.01. Data expressed as mean ± SEM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97364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Table 1. List of all antibodies used for the analysis of islets via flow cytometry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86EA42C-C7EB-4F8D-BD60-AD0375D4C524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4963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BCA090-37BD-4948-83C9-22F7300F98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6432A0-828E-4171-B2FD-7AACB77CC7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E36F90-3C8E-44C0-A722-358661679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2A3B87-245C-4BCE-A54D-8BC092798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67847-FDA8-483E-B535-5DB8CBBB87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56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3048E-CABB-470F-A9E9-10F8EB1B9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CC3AC2-6DD9-4A94-BF7F-64FF369E21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41DB21-E2CE-4A03-B580-E6188365E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456CDC-BFF1-4008-A81A-253EAFAA3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98E14-F399-4F60-8E52-E96DE6E9AB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31841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34B2A2-12A3-4E7B-AE5D-B2372CBD5E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30E559-4BC2-4812-8960-5927D5045A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E8ABBB-A020-415D-9DE1-4E1909521D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13CF93-D6DB-48CE-B563-E6938D6CF4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F37F95-76B3-4CC6-83A6-ADA148EDA7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002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84698-3BD9-4C2C-993E-AE3A75F371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787E07-8A2A-4792-B460-E617DB7989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98C76-0B9F-4B78-84F4-66AA17FC9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1D9D13-A706-487C-AB47-D3CC3B1970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A24EC1-7B93-4375-8371-F770D24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596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7C344-6214-4B87-BD1D-D13E601ABD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FECA9F-EBF9-4112-BF47-73A266F172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EA3BC8-4EC8-4375-87CA-DBE17745A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C44EF5-E0CC-420D-8EA3-951041178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9C10BB-AE66-4CB1-AF16-8F1A08E9B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161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51755-3C11-4ECC-9F13-CA948ECF9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A53E71-70A3-4005-91EF-DE2DE1A717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E84348-5FD0-4EE8-BB2C-CA28BC6830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565EAD-C471-45C2-8D6D-EE97B38ED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F5BFA4-D35B-4868-B60A-3BB9BCCF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508CA-E534-40C0-AC23-EFFA6B2CC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0303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468486-4B3F-4DF2-92A1-FAC0C916E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526650-5B85-4FBF-905A-248BD1A57C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03DEDDB-93D8-489A-A018-4AE264F638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66F476-494E-4379-AA70-6C58F472FC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F901D4-19D7-411B-959C-AB1E0FFFBC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7C7620-BD2A-4EE1-8408-6D6E7F6D4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634F0D4-869A-47B1-B574-3B7BC43C6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5CBEB34-647C-438F-8527-469D14B60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762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55F8D-FE75-4EC5-9C48-FC922BE76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176429D-4373-49CC-8609-339D5F113F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D01913-6E3D-4FB0-8E5B-B56C0E184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C00488-FBD7-4CB0-8287-26E9904B4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985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0452231-E5AC-4582-B271-03222DCB7D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7A31E7-CE49-4023-8379-D144A6510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7D6E1ED-0FC0-49AC-A931-865EA9998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123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DEF632-DE90-4AEE-911E-C7181A85A7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979789-00B1-4378-A8FD-ED8DE8694E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3000A2-1B33-445F-8CB9-C237F0E538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F228E8-FEB7-4450-82A8-8D48E0A81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6BB8DB-79EB-40EE-A43A-394499990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FA8BE8-067F-4B2A-926F-F64F60E5D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230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5E40CC-C259-4D28-8ED4-CACD711495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5C108C-94B0-48BB-974B-FA66FFCE21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5A8C74-9E1A-4357-9FC3-4177F7E0AE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C1E1B3-745B-4763-9258-80D48CB6B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0FD14B-5528-44B1-9147-FA54BE64D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ADF799-678E-4DE1-B065-C3494B85F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491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302825-788D-49CB-816A-7E30C08AD0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F45E55-D41C-4CAF-AFF4-5230B6F8E3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7EA5E6-DAE3-4970-A267-62F3A8C616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F28D0-C116-4A14-8FD5-AC5A058E23E7}" type="datetimeFigureOut">
              <a:rPr lang="en-US" smtClean="0"/>
              <a:t>6/4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89015-56B2-4C69-8328-6903B67EB6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9FB6EF-B6EF-4591-8733-8A37378FDB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0BE6F-1ADA-4450-95BD-9FE7EEA4BD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349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790D376-3085-4308-A19A-AAEC29292A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1075" y="1814512"/>
            <a:ext cx="2609850" cy="3228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5665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4078EC2-35E7-453D-8CA4-7D5AEB05F7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1075" y="1814512"/>
            <a:ext cx="2609850" cy="3228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92013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CCB1726-A371-4BF1-AD30-B692F8D74F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2975" y="1795462"/>
            <a:ext cx="2686050" cy="3267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88798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11231134-8A07-41E5-A868-EC1B06CFF6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48085" y="3356246"/>
            <a:ext cx="1943100" cy="347662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48462AE-7595-4FC9-ADAF-AF85AEC110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60190" y="3530705"/>
            <a:ext cx="3781425" cy="280035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62FC579-EBAD-413E-96FD-51BADEBC9B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91523" y="40914"/>
            <a:ext cx="3876675" cy="28194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0EE3A7A-7C9E-4F83-9403-D403A2094C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49515" y="50439"/>
            <a:ext cx="3876675" cy="280987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1AE95F5-B2D1-497C-89DA-EE7842DFA2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651131" y="40914"/>
            <a:ext cx="3876675" cy="28194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A20EC47-A145-4439-A450-591043BB60EA}"/>
              </a:ext>
            </a:extLst>
          </p:cNvPr>
          <p:cNvSpPr txBox="1"/>
          <p:nvPr/>
        </p:nvSpPr>
        <p:spPr>
          <a:xfrm>
            <a:off x="9980" y="-3480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6FA1F4-6433-4262-BC58-A109AE8E13CE}"/>
              </a:ext>
            </a:extLst>
          </p:cNvPr>
          <p:cNvSpPr txBox="1"/>
          <p:nvPr/>
        </p:nvSpPr>
        <p:spPr>
          <a:xfrm>
            <a:off x="4364260" y="-3480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CED014A-B9D3-47AD-9E0D-B9168B463025}"/>
              </a:ext>
            </a:extLst>
          </p:cNvPr>
          <p:cNvSpPr txBox="1"/>
          <p:nvPr/>
        </p:nvSpPr>
        <p:spPr>
          <a:xfrm>
            <a:off x="8706833" y="-3480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84BADBD-A05A-4CE4-93DC-10D1CFB3AE8E}"/>
              </a:ext>
            </a:extLst>
          </p:cNvPr>
          <p:cNvSpPr txBox="1"/>
          <p:nvPr/>
        </p:nvSpPr>
        <p:spPr>
          <a:xfrm>
            <a:off x="2835037" y="346647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4C015E7-0D8D-4BB1-9BCE-2B4301236B35}"/>
              </a:ext>
            </a:extLst>
          </p:cNvPr>
          <p:cNvSpPr txBox="1"/>
          <p:nvPr/>
        </p:nvSpPr>
        <p:spPr>
          <a:xfrm>
            <a:off x="8040536" y="346647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8012423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2077C9C-F936-494B-97CF-94F3F60922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7413" y="3593747"/>
            <a:ext cx="2162175" cy="328612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F84BADBD-A05A-4CE4-93DC-10D1CFB3AE8E}"/>
              </a:ext>
            </a:extLst>
          </p:cNvPr>
          <p:cNvSpPr txBox="1"/>
          <p:nvPr/>
        </p:nvSpPr>
        <p:spPr>
          <a:xfrm>
            <a:off x="1402074" y="0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4C015E7-0D8D-4BB1-9BCE-2B4301236B35}"/>
              </a:ext>
            </a:extLst>
          </p:cNvPr>
          <p:cNvSpPr txBox="1"/>
          <p:nvPr/>
        </p:nvSpPr>
        <p:spPr>
          <a:xfrm>
            <a:off x="7226867" y="-2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G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0E692D0-A663-400E-9CBB-BF7CBD59BC12}"/>
              </a:ext>
            </a:extLst>
          </p:cNvPr>
          <p:cNvSpPr txBox="1"/>
          <p:nvPr/>
        </p:nvSpPr>
        <p:spPr>
          <a:xfrm>
            <a:off x="1382657" y="3304425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H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EC3282F-FBD8-4424-87C9-3978E567D7EA}"/>
              </a:ext>
            </a:extLst>
          </p:cNvPr>
          <p:cNvSpPr txBox="1"/>
          <p:nvPr/>
        </p:nvSpPr>
        <p:spPr>
          <a:xfrm>
            <a:off x="7257323" y="3304426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1716989C-8260-42F1-90EB-716B79863F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80219" y="272326"/>
            <a:ext cx="3994873" cy="280720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ACB641AA-D4A9-4D8D-ADB1-B8440BD74A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56511" y="272326"/>
            <a:ext cx="3994873" cy="280720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9158A95-4D35-43D0-8FA2-CB8CF2A67B3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85357" y="3576753"/>
            <a:ext cx="3994873" cy="2807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0998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CAD957AD-9647-4F75-990F-5BB20506514D}"/>
              </a:ext>
            </a:extLst>
          </p:cNvPr>
          <p:cNvGraphicFramePr>
            <a:graphicFrameLocks noGrp="1"/>
          </p:cNvGraphicFramePr>
          <p:nvPr/>
        </p:nvGraphicFramePr>
        <p:xfrm>
          <a:off x="0" y="471469"/>
          <a:ext cx="12192000" cy="37693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48348">
                  <a:extLst>
                    <a:ext uri="{9D8B030D-6E8A-4147-A177-3AD203B41FA5}">
                      <a16:colId xmlns:a16="http://schemas.microsoft.com/office/drawing/2014/main" val="2689276686"/>
                    </a:ext>
                  </a:extLst>
                </a:gridCol>
                <a:gridCol w="2355925">
                  <a:extLst>
                    <a:ext uri="{9D8B030D-6E8A-4147-A177-3AD203B41FA5}">
                      <a16:colId xmlns:a16="http://schemas.microsoft.com/office/drawing/2014/main" val="3412026275"/>
                    </a:ext>
                  </a:extLst>
                </a:gridCol>
                <a:gridCol w="1044066">
                  <a:extLst>
                    <a:ext uri="{9D8B030D-6E8A-4147-A177-3AD203B41FA5}">
                      <a16:colId xmlns:a16="http://schemas.microsoft.com/office/drawing/2014/main" val="2644562757"/>
                    </a:ext>
                  </a:extLst>
                </a:gridCol>
                <a:gridCol w="6543661">
                  <a:extLst>
                    <a:ext uri="{9D8B030D-6E8A-4147-A177-3AD203B41FA5}">
                      <a16:colId xmlns:a16="http://schemas.microsoft.com/office/drawing/2014/main" val="156945969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alog # and Manufacturer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90700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-conjugated anti-insulin 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8508, CST, Danvers, MA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eta cells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882868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-conjugated anti-glucagon 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NBP2-21803AF647, Novus Biological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pha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03607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exa Fluor 488-conjugated anti-somatostatin 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566032, BD Bioscience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ta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820462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TC-conjugated anti-GLUT2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FAB1414G-100UG, Novus Biological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uble staining with anti-insulin antibody to identify GLUT2-positive, insulin-positive beta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439600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TC-conjugated anti-</a:t>
                      </a: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urogenin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3 (Ngn3)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bs-0922R, </a:t>
                      </a:r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ss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gn3-positive pancreatic progenitor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8616093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C-conjugated anti-Nkx6.1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563338, BD Pharmingen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kx6.1-positive pancreatic progenitor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42980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-conjugated anti-Ki-6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12-5698-82, Invitrogen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uble staining with anti-glucagon and anti-somatostatin antibodies to identify Ki-67-positive, glucagon-positive alpha cells and Ki-67-positive, somatostatin-positive delta cell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875618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kern="12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luor</a:t>
                      </a:r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660-conjugated anti-Ki-67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 #50-5698-82, Invitrogen</a:t>
                      </a:r>
                      <a:endParaRPr 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uble staining with anti-insulin antibody to identify Ki-67-positive, insulin-positive beta cells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77031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81820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197</Words>
  <Application>Microsoft Office PowerPoint</Application>
  <PresentationFormat>Widescreen</PresentationFormat>
  <Paragraphs>57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</dc:creator>
  <cp:lastModifiedBy>AL</cp:lastModifiedBy>
  <cp:revision>1</cp:revision>
  <dcterms:created xsi:type="dcterms:W3CDTF">2020-06-04T20:59:08Z</dcterms:created>
  <dcterms:modified xsi:type="dcterms:W3CDTF">2020-06-04T21:05:58Z</dcterms:modified>
</cp:coreProperties>
</file>